
<file path=[Content_Types].xml><?xml version="1.0" encoding="utf-8"?>
<Types xmlns="http://schemas.openxmlformats.org/package/2006/content-types"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81" r:id="rId2"/>
  </p:sldIdLst>
  <p:sldSz cx="12192000" cy="6858000"/>
  <p:notesSz cx="7010400" cy="92964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4472C4"/>
    <a:srgbClr val="000000"/>
    <a:srgbClr val="FFEFEF"/>
    <a:srgbClr val="F1F8EC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72385" autoAdjust="0"/>
  </p:normalViewPr>
  <p:slideViewPr>
    <p:cSldViewPr snapToGrid="0">
      <p:cViewPr varScale="1">
        <p:scale>
          <a:sx n="79" d="100"/>
          <a:sy n="79" d="100"/>
        </p:scale>
        <p:origin x="1716" y="7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00" d="100"/>
        <a:sy n="10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microsoft.com/office/2016/11/relationships/changesInfo" Target="changesInfos/changesInfo1.xml"/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Ren, Hening" userId="1ad506b0-93f1-4f52-90fb-3dd1b2ccac5e" providerId="ADAL" clId="{A670AE21-219F-471E-9CEA-1155E155C5D5}"/>
    <pc:docChg chg="undo custSel addSld delSld modSld">
      <pc:chgData name="Ren, Hening" userId="1ad506b0-93f1-4f52-90fb-3dd1b2ccac5e" providerId="ADAL" clId="{A670AE21-219F-471E-9CEA-1155E155C5D5}" dt="2024-05-30T17:34:05.490" v="40" actId="47"/>
      <pc:docMkLst>
        <pc:docMk/>
      </pc:docMkLst>
      <pc:sldChg chg="add del">
        <pc:chgData name="Ren, Hening" userId="1ad506b0-93f1-4f52-90fb-3dd1b2ccac5e" providerId="ADAL" clId="{A670AE21-219F-471E-9CEA-1155E155C5D5}" dt="2024-05-30T17:34:05.490" v="40" actId="47"/>
        <pc:sldMkLst>
          <pc:docMk/>
          <pc:sldMk cId="1678725815" sldId="258"/>
        </pc:sldMkLst>
      </pc:sldChg>
      <pc:sldChg chg="addSp modSp mod">
        <pc:chgData name="Ren, Hening" userId="1ad506b0-93f1-4f52-90fb-3dd1b2ccac5e" providerId="ADAL" clId="{A670AE21-219F-471E-9CEA-1155E155C5D5}" dt="2024-05-30T17:33:50.461" v="39" actId="1076"/>
        <pc:sldMkLst>
          <pc:docMk/>
          <pc:sldMk cId="2260493923" sldId="281"/>
        </pc:sldMkLst>
        <pc:spChg chg="add mod">
          <ac:chgData name="Ren, Hening" userId="1ad506b0-93f1-4f52-90fb-3dd1b2ccac5e" providerId="ADAL" clId="{A670AE21-219F-471E-9CEA-1155E155C5D5}" dt="2024-05-30T17:33:50.461" v="39" actId="1076"/>
          <ac:spMkLst>
            <pc:docMk/>
            <pc:sldMk cId="2260493923" sldId="281"/>
            <ac:spMk id="5" creationId="{D3C78C79-9464-3BB9-E225-A8C2EC88F9B7}"/>
          </ac:spMkLst>
        </pc:spChg>
        <pc:spChg chg="mod">
          <ac:chgData name="Ren, Hening" userId="1ad506b0-93f1-4f52-90fb-3dd1b2ccac5e" providerId="ADAL" clId="{A670AE21-219F-471E-9CEA-1155E155C5D5}" dt="2024-05-30T17:32:50.686" v="25" actId="1036"/>
          <ac:spMkLst>
            <pc:docMk/>
            <pc:sldMk cId="2260493923" sldId="281"/>
            <ac:spMk id="6" creationId="{3FCD1E82-9A4F-CC35-F85D-122F5B0EFA63}"/>
          </ac:spMkLst>
        </pc:spChg>
        <pc:spChg chg="mod">
          <ac:chgData name="Ren, Hening" userId="1ad506b0-93f1-4f52-90fb-3dd1b2ccac5e" providerId="ADAL" clId="{A670AE21-219F-471E-9CEA-1155E155C5D5}" dt="2024-05-30T17:32:50.686" v="25" actId="1036"/>
          <ac:spMkLst>
            <pc:docMk/>
            <pc:sldMk cId="2260493923" sldId="281"/>
            <ac:spMk id="7" creationId="{0E621AD0-6DE7-EA2F-2D89-87C35C3838F3}"/>
          </ac:spMkLst>
        </pc:spChg>
        <pc:spChg chg="mod">
          <ac:chgData name="Ren, Hening" userId="1ad506b0-93f1-4f52-90fb-3dd1b2ccac5e" providerId="ADAL" clId="{A670AE21-219F-471E-9CEA-1155E155C5D5}" dt="2024-05-30T17:32:50.686" v="25" actId="1036"/>
          <ac:spMkLst>
            <pc:docMk/>
            <pc:sldMk cId="2260493923" sldId="281"/>
            <ac:spMk id="8" creationId="{A763E5BA-3F8C-190F-8902-D2F5F02918FC}"/>
          </ac:spMkLst>
        </pc:spChg>
        <pc:spChg chg="mod">
          <ac:chgData name="Ren, Hening" userId="1ad506b0-93f1-4f52-90fb-3dd1b2ccac5e" providerId="ADAL" clId="{A670AE21-219F-471E-9CEA-1155E155C5D5}" dt="2024-05-30T17:32:50.686" v="25" actId="1036"/>
          <ac:spMkLst>
            <pc:docMk/>
            <pc:sldMk cId="2260493923" sldId="281"/>
            <ac:spMk id="9" creationId="{59F21F46-71A2-F14E-A111-DC30B1886E58}"/>
          </ac:spMkLst>
        </pc:spChg>
        <pc:graphicFrameChg chg="mod">
          <ac:chgData name="Ren, Hening" userId="1ad506b0-93f1-4f52-90fb-3dd1b2ccac5e" providerId="ADAL" clId="{A670AE21-219F-471E-9CEA-1155E155C5D5}" dt="2024-05-30T17:32:50.686" v="25" actId="1036"/>
          <ac:graphicFrameMkLst>
            <pc:docMk/>
            <pc:sldMk cId="2260493923" sldId="281"/>
            <ac:graphicFrameMk id="3" creationId="{72ADC21E-4590-F05C-187E-16F31C462A8D}"/>
          </ac:graphicFrameMkLst>
        </pc:graphicFrameChg>
        <pc:graphicFrameChg chg="mod">
          <ac:chgData name="Ren, Hening" userId="1ad506b0-93f1-4f52-90fb-3dd1b2ccac5e" providerId="ADAL" clId="{A670AE21-219F-471E-9CEA-1155E155C5D5}" dt="2024-05-30T17:32:50.686" v="25" actId="1036"/>
          <ac:graphicFrameMkLst>
            <pc:docMk/>
            <pc:sldMk cId="2260493923" sldId="281"/>
            <ac:graphicFrameMk id="4" creationId="{72ADC21E-4590-F05C-187E-16F31C462A8D}"/>
          </ac:graphicFrameMkLst>
        </pc:graphicFrameChg>
      </pc:sldChg>
    </pc:docChg>
  </pc:docChgLst>
  <pc:docChgLst>
    <pc:chgData name="Ren, Hening" userId="1ad506b0-93f1-4f52-90fb-3dd1b2ccac5e" providerId="ADAL" clId="{7076AEFD-6494-412A-AB6C-5BDFA89E0A32}"/>
    <pc:docChg chg="undo redo custSel modSld">
      <pc:chgData name="Ren, Hening" userId="1ad506b0-93f1-4f52-90fb-3dd1b2ccac5e" providerId="ADAL" clId="{7076AEFD-6494-412A-AB6C-5BDFA89E0A32}" dt="2024-07-10T16:41:27.156" v="39" actId="478"/>
      <pc:docMkLst>
        <pc:docMk/>
      </pc:docMkLst>
      <pc:sldChg chg="addSp delSp modSp mod">
        <pc:chgData name="Ren, Hening" userId="1ad506b0-93f1-4f52-90fb-3dd1b2ccac5e" providerId="ADAL" clId="{7076AEFD-6494-412A-AB6C-5BDFA89E0A32}" dt="2024-07-10T16:41:27.156" v="39" actId="478"/>
        <pc:sldMkLst>
          <pc:docMk/>
          <pc:sldMk cId="2260493923" sldId="281"/>
        </pc:sldMkLst>
        <pc:spChg chg="del mod">
          <ac:chgData name="Ren, Hening" userId="1ad506b0-93f1-4f52-90fb-3dd1b2ccac5e" providerId="ADAL" clId="{7076AEFD-6494-412A-AB6C-5BDFA89E0A32}" dt="2024-07-10T16:41:27.156" v="39" actId="478"/>
          <ac:spMkLst>
            <pc:docMk/>
            <pc:sldMk cId="2260493923" sldId="281"/>
            <ac:spMk id="5" creationId="{D3C78C79-9464-3BB9-E225-A8C2EC88F9B7}"/>
          </ac:spMkLst>
        </pc:spChg>
        <pc:spChg chg="mod">
          <ac:chgData name="Ren, Hening" userId="1ad506b0-93f1-4f52-90fb-3dd1b2ccac5e" providerId="ADAL" clId="{7076AEFD-6494-412A-AB6C-5BDFA89E0A32}" dt="2024-07-10T16:23:40.510" v="32" actId="1035"/>
          <ac:spMkLst>
            <pc:docMk/>
            <pc:sldMk cId="2260493923" sldId="281"/>
            <ac:spMk id="6" creationId="{3FCD1E82-9A4F-CC35-F85D-122F5B0EFA63}"/>
          </ac:spMkLst>
        </pc:spChg>
        <pc:spChg chg="mod">
          <ac:chgData name="Ren, Hening" userId="1ad506b0-93f1-4f52-90fb-3dd1b2ccac5e" providerId="ADAL" clId="{7076AEFD-6494-412A-AB6C-5BDFA89E0A32}" dt="2024-07-10T16:23:40.510" v="32" actId="1035"/>
          <ac:spMkLst>
            <pc:docMk/>
            <pc:sldMk cId="2260493923" sldId="281"/>
            <ac:spMk id="7" creationId="{0E621AD0-6DE7-EA2F-2D89-87C35C3838F3}"/>
          </ac:spMkLst>
        </pc:spChg>
        <pc:spChg chg="mod">
          <ac:chgData name="Ren, Hening" userId="1ad506b0-93f1-4f52-90fb-3dd1b2ccac5e" providerId="ADAL" clId="{7076AEFD-6494-412A-AB6C-5BDFA89E0A32}" dt="2024-07-10T16:23:40.510" v="32" actId="1035"/>
          <ac:spMkLst>
            <pc:docMk/>
            <pc:sldMk cId="2260493923" sldId="281"/>
            <ac:spMk id="8" creationId="{A763E5BA-3F8C-190F-8902-D2F5F02918FC}"/>
          </ac:spMkLst>
        </pc:spChg>
        <pc:spChg chg="mod">
          <ac:chgData name="Ren, Hening" userId="1ad506b0-93f1-4f52-90fb-3dd1b2ccac5e" providerId="ADAL" clId="{7076AEFD-6494-412A-AB6C-5BDFA89E0A32}" dt="2024-07-10T16:23:40.510" v="32" actId="1035"/>
          <ac:spMkLst>
            <pc:docMk/>
            <pc:sldMk cId="2260493923" sldId="281"/>
            <ac:spMk id="9" creationId="{59F21F46-71A2-F14E-A111-DC30B1886E58}"/>
          </ac:spMkLst>
        </pc:spChg>
        <pc:spChg chg="add mod">
          <ac:chgData name="Ren, Hening" userId="1ad506b0-93f1-4f52-90fb-3dd1b2ccac5e" providerId="ADAL" clId="{7076AEFD-6494-412A-AB6C-5BDFA89E0A32}" dt="2024-07-10T16:24:01.855" v="38" actId="20577"/>
          <ac:spMkLst>
            <pc:docMk/>
            <pc:sldMk cId="2260493923" sldId="281"/>
            <ac:spMk id="10" creationId="{F1EE9AC3-EDFC-D2A3-2E47-577AFA2EA41B}"/>
          </ac:spMkLst>
        </pc:spChg>
        <pc:graphicFrameChg chg="mod">
          <ac:chgData name="Ren, Hening" userId="1ad506b0-93f1-4f52-90fb-3dd1b2ccac5e" providerId="ADAL" clId="{7076AEFD-6494-412A-AB6C-5BDFA89E0A32}" dt="2024-07-10T16:23:40.510" v="32" actId="1035"/>
          <ac:graphicFrameMkLst>
            <pc:docMk/>
            <pc:sldMk cId="2260493923" sldId="281"/>
            <ac:graphicFrameMk id="3" creationId="{72ADC21E-4590-F05C-187E-16F31C462A8D}"/>
          </ac:graphicFrameMkLst>
        </pc:graphicFrameChg>
        <pc:graphicFrameChg chg="mod">
          <ac:chgData name="Ren, Hening" userId="1ad506b0-93f1-4f52-90fb-3dd1b2ccac5e" providerId="ADAL" clId="{7076AEFD-6494-412A-AB6C-5BDFA89E0A32}" dt="2024-07-10T16:23:40.510" v="32" actId="1035"/>
          <ac:graphicFrameMkLst>
            <pc:docMk/>
            <pc:sldMk cId="2260493923" sldId="281"/>
            <ac:graphicFrameMk id="4" creationId="{72ADC21E-4590-F05C-187E-16F31C462A8D}"/>
          </ac:graphicFrameMkLst>
        </pc:graphicFrameChg>
      </pc:sldChg>
    </pc:docChg>
  </pc:docChgLst>
</pc:chgInfo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https://umbcits-my.sharepoint.com/personal/hren_umaryland_edu/Documents/219%20naive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https://umbcits-my.sharepoint.com/personal/hren_umaryland_edu/Documents/219%20naive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7718776363445402"/>
          <c:y val="4.4608259968126007E-2"/>
          <c:w val="0.7773741076661933"/>
          <c:h val="0.81993143036688931"/>
        </c:manualLayout>
      </c:layout>
      <c:scatterChart>
        <c:scatterStyle val="smoothMarker"/>
        <c:varyColors val="0"/>
        <c:ser>
          <c:idx val="0"/>
          <c:order val="0"/>
          <c:tx>
            <c:strRef>
              <c:f>'[219 naive.xlsx]Sheet1'!$B$2</c:f>
              <c:strCache>
                <c:ptCount val="1"/>
                <c:pt idx="0">
                  <c:v>14L</c:v>
                </c:pt>
              </c:strCache>
            </c:strRef>
          </c:tx>
          <c:spPr>
            <a:ln w="19050" cap="rnd">
              <a:solidFill>
                <a:schemeClr val="accent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xVal>
            <c:numRef>
              <c:f>'[219 naive.xlsx]Sheet1'!$A$3:$A$11</c:f>
              <c:numCache>
                <c:formatCode>General</c:formatCode>
                <c:ptCount val="9"/>
                <c:pt idx="0">
                  <c:v>0</c:v>
                </c:pt>
                <c:pt idx="1">
                  <c:v>3</c:v>
                </c:pt>
                <c:pt idx="2">
                  <c:v>7</c:v>
                </c:pt>
                <c:pt idx="3">
                  <c:v>10</c:v>
                </c:pt>
                <c:pt idx="4">
                  <c:v>14</c:v>
                </c:pt>
                <c:pt idx="5">
                  <c:v>17</c:v>
                </c:pt>
                <c:pt idx="6">
                  <c:v>21</c:v>
                </c:pt>
                <c:pt idx="7">
                  <c:v>24</c:v>
                </c:pt>
                <c:pt idx="8">
                  <c:v>28</c:v>
                </c:pt>
              </c:numCache>
            </c:numRef>
          </c:xVal>
          <c:yVal>
            <c:numRef>
              <c:f>'[219 naive.xlsx]Sheet1'!$B$3:$B$11</c:f>
              <c:numCache>
                <c:formatCode>General</c:formatCode>
                <c:ptCount val="9"/>
                <c:pt idx="0">
                  <c:v>49.39</c:v>
                </c:pt>
                <c:pt idx="1">
                  <c:v>116.03</c:v>
                </c:pt>
                <c:pt idx="2">
                  <c:v>172.65</c:v>
                </c:pt>
                <c:pt idx="3">
                  <c:v>202.55</c:v>
                </c:pt>
                <c:pt idx="4">
                  <c:v>285.91000000000003</c:v>
                </c:pt>
                <c:pt idx="5">
                  <c:v>334.61</c:v>
                </c:pt>
                <c:pt idx="6">
                  <c:v>487.35</c:v>
                </c:pt>
                <c:pt idx="7">
                  <c:v>550.38</c:v>
                </c:pt>
                <c:pt idx="8">
                  <c:v>639.27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0-459B-405F-B64B-0D854B28483D}"/>
            </c:ext>
          </c:extLst>
        </c:ser>
        <c:ser>
          <c:idx val="1"/>
          <c:order val="1"/>
          <c:tx>
            <c:strRef>
              <c:f>'[219 naive.xlsx]Sheet1'!$C$2</c:f>
              <c:strCache>
                <c:ptCount val="1"/>
                <c:pt idx="0">
                  <c:v>15L</c:v>
                </c:pt>
              </c:strCache>
            </c:strRef>
          </c:tx>
          <c:spPr>
            <a:ln w="19050" cap="rnd">
              <a:solidFill>
                <a:schemeClr val="accent2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2"/>
              </a:solidFill>
              <a:ln w="9525">
                <a:solidFill>
                  <a:schemeClr val="accent2"/>
                </a:solidFill>
              </a:ln>
              <a:effectLst/>
            </c:spPr>
          </c:marker>
          <c:xVal>
            <c:numRef>
              <c:f>'[219 naive.xlsx]Sheet1'!$A$3:$A$11</c:f>
              <c:numCache>
                <c:formatCode>General</c:formatCode>
                <c:ptCount val="9"/>
                <c:pt idx="0">
                  <c:v>0</c:v>
                </c:pt>
                <c:pt idx="1">
                  <c:v>3</c:v>
                </c:pt>
                <c:pt idx="2">
                  <c:v>7</c:v>
                </c:pt>
                <c:pt idx="3">
                  <c:v>10</c:v>
                </c:pt>
                <c:pt idx="4">
                  <c:v>14</c:v>
                </c:pt>
                <c:pt idx="5">
                  <c:v>17</c:v>
                </c:pt>
                <c:pt idx="6">
                  <c:v>21</c:v>
                </c:pt>
                <c:pt idx="7">
                  <c:v>24</c:v>
                </c:pt>
                <c:pt idx="8">
                  <c:v>28</c:v>
                </c:pt>
              </c:numCache>
            </c:numRef>
          </c:xVal>
          <c:yVal>
            <c:numRef>
              <c:f>'[219 naive.xlsx]Sheet1'!$C$3:$C$11</c:f>
              <c:numCache>
                <c:formatCode>General</c:formatCode>
                <c:ptCount val="9"/>
                <c:pt idx="0">
                  <c:v>75.92</c:v>
                </c:pt>
                <c:pt idx="1">
                  <c:v>124.43</c:v>
                </c:pt>
                <c:pt idx="2">
                  <c:v>196.2</c:v>
                </c:pt>
                <c:pt idx="3">
                  <c:v>244.48</c:v>
                </c:pt>
                <c:pt idx="4">
                  <c:v>287.91999999999996</c:v>
                </c:pt>
                <c:pt idx="5">
                  <c:v>353.75</c:v>
                </c:pt>
                <c:pt idx="6">
                  <c:v>398.75</c:v>
                </c:pt>
                <c:pt idx="7">
                  <c:v>471.5</c:v>
                </c:pt>
                <c:pt idx="8">
                  <c:v>549.35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1-459B-405F-B64B-0D854B28483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175081039"/>
        <c:axId val="1175090639"/>
        <c:extLst>
          <c:ext xmlns:c15="http://schemas.microsoft.com/office/drawing/2012/chart" uri="{02D57815-91ED-43cb-92C2-25804820EDAC}">
            <c15:filteredScatterSeries>
              <c15:ser>
                <c:idx val="2"/>
                <c:order val="2"/>
                <c:tx>
                  <c:strRef>
                    <c:extLst>
                      <c:ext uri="{02D57815-91ED-43cb-92C2-25804820EDAC}">
                        <c15:formulaRef>
                          <c15:sqref>'[219 naive.xlsx]Sheet1'!$D$2</c15:sqref>
                        </c15:formulaRef>
                      </c:ext>
                    </c:extLst>
                    <c:strCache>
                      <c:ptCount val="1"/>
                      <c:pt idx="0">
                        <c:v>30L</c:v>
                      </c:pt>
                    </c:strCache>
                  </c:strRef>
                </c:tx>
                <c:spPr>
                  <a:ln w="19050" cap="rnd">
                    <a:solidFill>
                      <a:schemeClr val="accent3"/>
                    </a:solidFill>
                    <a:round/>
                  </a:ln>
                  <a:effectLst/>
                </c:spPr>
                <c:marker>
                  <c:symbol val="circle"/>
                  <c:size val="5"/>
                  <c:spPr>
                    <a:solidFill>
                      <a:schemeClr val="accent3"/>
                    </a:solidFill>
                    <a:ln w="9525">
                      <a:solidFill>
                        <a:schemeClr val="accent3"/>
                      </a:solidFill>
                    </a:ln>
                    <a:effectLst/>
                  </c:spPr>
                </c:marker>
                <c:xVal>
                  <c:numRef>
                    <c:extLst>
                      <c:ext uri="{02D57815-91ED-43cb-92C2-25804820EDAC}">
                        <c15:formulaRef>
                          <c15:sqref>'[219 naive.xlsx]Sheet1'!$A$3:$A$11</c15:sqref>
                        </c15:formulaRef>
                      </c:ext>
                    </c:extLst>
                    <c:numCache>
                      <c:formatCode>General</c:formatCode>
                      <c:ptCount val="9"/>
                      <c:pt idx="0">
                        <c:v>0</c:v>
                      </c:pt>
                      <c:pt idx="1">
                        <c:v>3</c:v>
                      </c:pt>
                      <c:pt idx="2">
                        <c:v>7</c:v>
                      </c:pt>
                      <c:pt idx="3">
                        <c:v>10</c:v>
                      </c:pt>
                      <c:pt idx="4">
                        <c:v>14</c:v>
                      </c:pt>
                      <c:pt idx="5">
                        <c:v>17</c:v>
                      </c:pt>
                      <c:pt idx="6">
                        <c:v>21</c:v>
                      </c:pt>
                      <c:pt idx="7">
                        <c:v>24</c:v>
                      </c:pt>
                      <c:pt idx="8">
                        <c:v>28</c:v>
                      </c:pt>
                    </c:numCache>
                  </c:numRef>
                </c:xVal>
                <c:yVal>
                  <c:numRef>
                    <c:extLst>
                      <c:ext uri="{02D57815-91ED-43cb-92C2-25804820EDAC}">
                        <c15:formulaRef>
                          <c15:sqref>'[219 naive.xlsx]Sheet1'!$D$3:$D$11</c15:sqref>
                        </c15:formulaRef>
                      </c:ext>
                    </c:extLst>
                    <c:numCache>
                      <c:formatCode>General</c:formatCode>
                      <c:ptCount val="9"/>
                      <c:pt idx="0">
                        <c:v>106</c:v>
                      </c:pt>
                      <c:pt idx="1">
                        <c:v>133</c:v>
                      </c:pt>
                      <c:pt idx="2">
                        <c:v>200</c:v>
                      </c:pt>
                      <c:pt idx="3">
                        <c:v>265</c:v>
                      </c:pt>
                      <c:pt idx="4">
                        <c:v>314</c:v>
                      </c:pt>
                      <c:pt idx="5">
                        <c:v>371</c:v>
                      </c:pt>
                      <c:pt idx="6">
                        <c:v>423</c:v>
                      </c:pt>
                      <c:pt idx="7">
                        <c:v>480</c:v>
                      </c:pt>
                      <c:pt idx="8">
                        <c:v>522</c:v>
                      </c:pt>
                    </c:numCache>
                  </c:numRef>
                </c:yVal>
                <c:smooth val="1"/>
                <c:extLst>
                  <c:ext xmlns:c16="http://schemas.microsoft.com/office/drawing/2014/chart" uri="{C3380CC4-5D6E-409C-BE32-E72D297353CC}">
                    <c16:uniqueId val="{00000002-459B-405F-B64B-0D854B28483D}"/>
                  </c:ext>
                </c:extLst>
              </c15:ser>
            </c15:filteredScatterSeries>
            <c15:filteredScatterSeries>
              <c15:ser>
                <c:idx val="3"/>
                <c:order val="3"/>
                <c:tx>
                  <c:str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[219 naive.xlsx]Sheet1'!$E$2</c15:sqref>
                        </c15:formulaRef>
                      </c:ext>
                    </c:extLst>
                    <c:strCache>
                      <c:ptCount val="1"/>
                      <c:pt idx="0">
                        <c:v>30R</c:v>
                      </c:pt>
                    </c:strCache>
                  </c:strRef>
                </c:tx>
                <c:spPr>
                  <a:ln w="19050" cap="rnd">
                    <a:solidFill>
                      <a:schemeClr val="accent4"/>
                    </a:solidFill>
                    <a:round/>
                  </a:ln>
                  <a:effectLst/>
                </c:spPr>
                <c:marker>
                  <c:symbol val="circle"/>
                  <c:size val="5"/>
                  <c:spPr>
                    <a:solidFill>
                      <a:schemeClr val="accent4"/>
                    </a:solidFill>
                    <a:ln w="9525">
                      <a:solidFill>
                        <a:schemeClr val="accent4"/>
                      </a:solidFill>
                    </a:ln>
                    <a:effectLst/>
                  </c:spPr>
                </c:marker>
                <c:xVal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[219 naive.xlsx]Sheet1'!$A$3:$A$11</c15:sqref>
                        </c15:formulaRef>
                      </c:ext>
                    </c:extLst>
                    <c:numCache>
                      <c:formatCode>General</c:formatCode>
                      <c:ptCount val="9"/>
                      <c:pt idx="0">
                        <c:v>0</c:v>
                      </c:pt>
                      <c:pt idx="1">
                        <c:v>3</c:v>
                      </c:pt>
                      <c:pt idx="2">
                        <c:v>7</c:v>
                      </c:pt>
                      <c:pt idx="3">
                        <c:v>10</c:v>
                      </c:pt>
                      <c:pt idx="4">
                        <c:v>14</c:v>
                      </c:pt>
                      <c:pt idx="5">
                        <c:v>17</c:v>
                      </c:pt>
                      <c:pt idx="6">
                        <c:v>21</c:v>
                      </c:pt>
                      <c:pt idx="7">
                        <c:v>24</c:v>
                      </c:pt>
                      <c:pt idx="8">
                        <c:v>28</c:v>
                      </c:pt>
                    </c:numCache>
                  </c:numRef>
                </c:xVal>
                <c:yVal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[219 naive.xlsx]Sheet1'!$E$3:$E$11</c15:sqref>
                        </c15:formulaRef>
                      </c:ext>
                    </c:extLst>
                    <c:numCache>
                      <c:formatCode>General</c:formatCode>
                      <c:ptCount val="9"/>
                      <c:pt idx="0">
                        <c:v>87.55</c:v>
                      </c:pt>
                      <c:pt idx="1">
                        <c:v>151.38</c:v>
                      </c:pt>
                      <c:pt idx="2">
                        <c:v>196.47</c:v>
                      </c:pt>
                      <c:pt idx="3">
                        <c:v>240.45</c:v>
                      </c:pt>
                      <c:pt idx="4">
                        <c:v>259.7</c:v>
                      </c:pt>
                      <c:pt idx="5">
                        <c:v>334.62</c:v>
                      </c:pt>
                      <c:pt idx="6">
                        <c:v>389.99</c:v>
                      </c:pt>
                      <c:pt idx="7">
                        <c:v>461.71</c:v>
                      </c:pt>
                      <c:pt idx="8">
                        <c:v>538.65</c:v>
                      </c:pt>
                    </c:numCache>
                  </c:numRef>
                </c:yVal>
                <c:smooth val="1"/>
                <c:extLst xmlns:c15="http://schemas.microsoft.com/office/drawing/2012/chart">
                  <c:ext xmlns:c16="http://schemas.microsoft.com/office/drawing/2014/chart" uri="{C3380CC4-5D6E-409C-BE32-E72D297353CC}">
                    <c16:uniqueId val="{00000003-459B-405F-B64B-0D854B28483D}"/>
                  </c:ext>
                </c:extLst>
              </c15:ser>
            </c15:filteredScatterSeries>
          </c:ext>
        </c:extLst>
      </c:scatterChart>
      <c:valAx>
        <c:axId val="1175081039"/>
        <c:scaling>
          <c:orientation val="minMax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200" b="1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1200" b="1" dirty="0">
                    <a:solidFill>
                      <a:schemeClr val="tx1"/>
                    </a:solidFill>
                  </a:rPr>
                  <a:t>Days after first dosing</a:t>
                </a:r>
              </a:p>
            </c:rich>
          </c:tx>
          <c:layout>
            <c:manualLayout>
              <c:xMode val="edge"/>
              <c:yMode val="edge"/>
              <c:x val="0.31374195394949184"/>
              <c:y val="0.95307086614173231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200" b="1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rgbClr val="00206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175090639"/>
        <c:crosses val="autoZero"/>
        <c:crossBetween val="midCat"/>
      </c:valAx>
      <c:valAx>
        <c:axId val="1175090639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200" b="1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1200" b="1">
                    <a:solidFill>
                      <a:schemeClr val="tx1"/>
                    </a:solidFill>
                  </a:rPr>
                  <a:t>Tumor Volume (mm3) </a:t>
                </a:r>
              </a:p>
            </c:rich>
          </c:tx>
          <c:layout>
            <c:manualLayout>
              <c:xMode val="edge"/>
              <c:yMode val="edge"/>
              <c:x val="3.0936497342056494E-3"/>
              <c:y val="0.23423870751638001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200" b="1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rgbClr val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175081039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solidFill>
        <a:srgbClr val="0070C0"/>
      </a:solidFill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7718776363445402"/>
          <c:y val="4.4608259968126007E-2"/>
          <c:w val="0.75585984218354552"/>
          <c:h val="0.81407168678295894"/>
        </c:manualLayout>
      </c:layout>
      <c:scatterChart>
        <c:scatterStyle val="smoothMarker"/>
        <c:varyColors val="0"/>
        <c:ser>
          <c:idx val="2"/>
          <c:order val="2"/>
          <c:tx>
            <c:strRef>
              <c:f>'[219 naive.xlsx]Sheet1'!$D$2</c:f>
              <c:strCache>
                <c:ptCount val="1"/>
                <c:pt idx="0">
                  <c:v>30L</c:v>
                </c:pt>
              </c:strCache>
            </c:strRef>
          </c:tx>
          <c:spPr>
            <a:ln w="19050" cap="rnd">
              <a:solidFill>
                <a:schemeClr val="accent3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3"/>
              </a:solidFill>
              <a:ln w="9525">
                <a:solidFill>
                  <a:schemeClr val="accent3"/>
                </a:solidFill>
              </a:ln>
              <a:effectLst/>
            </c:spPr>
          </c:marker>
          <c:xVal>
            <c:numRef>
              <c:f>'[219 naive.xlsx]Sheet1'!$A$3:$A$11</c:f>
              <c:numCache>
                <c:formatCode>General</c:formatCode>
                <c:ptCount val="9"/>
                <c:pt idx="0">
                  <c:v>0</c:v>
                </c:pt>
                <c:pt idx="1">
                  <c:v>3</c:v>
                </c:pt>
                <c:pt idx="2">
                  <c:v>7</c:v>
                </c:pt>
                <c:pt idx="3">
                  <c:v>10</c:v>
                </c:pt>
                <c:pt idx="4">
                  <c:v>14</c:v>
                </c:pt>
                <c:pt idx="5">
                  <c:v>17</c:v>
                </c:pt>
                <c:pt idx="6">
                  <c:v>21</c:v>
                </c:pt>
                <c:pt idx="7">
                  <c:v>24</c:v>
                </c:pt>
                <c:pt idx="8">
                  <c:v>28</c:v>
                </c:pt>
              </c:numCache>
            </c:numRef>
          </c:xVal>
          <c:yVal>
            <c:numRef>
              <c:f>'[219 naive.xlsx]Sheet1'!$D$3:$D$11</c:f>
              <c:numCache>
                <c:formatCode>General</c:formatCode>
                <c:ptCount val="9"/>
                <c:pt idx="0">
                  <c:v>106</c:v>
                </c:pt>
                <c:pt idx="1">
                  <c:v>133</c:v>
                </c:pt>
                <c:pt idx="2">
                  <c:v>200</c:v>
                </c:pt>
                <c:pt idx="3">
                  <c:v>265</c:v>
                </c:pt>
                <c:pt idx="4">
                  <c:v>314</c:v>
                </c:pt>
                <c:pt idx="5">
                  <c:v>371</c:v>
                </c:pt>
                <c:pt idx="6">
                  <c:v>423</c:v>
                </c:pt>
                <c:pt idx="7">
                  <c:v>480</c:v>
                </c:pt>
                <c:pt idx="8">
                  <c:v>522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0-D5F9-4722-AB73-12F80F0BB3B3}"/>
            </c:ext>
          </c:extLst>
        </c:ser>
        <c:ser>
          <c:idx val="3"/>
          <c:order val="3"/>
          <c:tx>
            <c:strRef>
              <c:f>'[219 naive.xlsx]Sheet1'!$E$2</c:f>
              <c:strCache>
                <c:ptCount val="1"/>
                <c:pt idx="0">
                  <c:v>30R</c:v>
                </c:pt>
              </c:strCache>
            </c:strRef>
          </c:tx>
          <c:spPr>
            <a:ln w="19050" cap="rnd">
              <a:solidFill>
                <a:schemeClr val="accent4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4"/>
              </a:solidFill>
              <a:ln w="9525">
                <a:solidFill>
                  <a:schemeClr val="accent4"/>
                </a:solidFill>
              </a:ln>
              <a:effectLst/>
            </c:spPr>
          </c:marker>
          <c:xVal>
            <c:numRef>
              <c:f>'[219 naive.xlsx]Sheet1'!$A$3:$A$11</c:f>
              <c:numCache>
                <c:formatCode>General</c:formatCode>
                <c:ptCount val="9"/>
                <c:pt idx="0">
                  <c:v>0</c:v>
                </c:pt>
                <c:pt idx="1">
                  <c:v>3</c:v>
                </c:pt>
                <c:pt idx="2">
                  <c:v>7</c:v>
                </c:pt>
                <c:pt idx="3">
                  <c:v>10</c:v>
                </c:pt>
                <c:pt idx="4">
                  <c:v>14</c:v>
                </c:pt>
                <c:pt idx="5">
                  <c:v>17</c:v>
                </c:pt>
                <c:pt idx="6">
                  <c:v>21</c:v>
                </c:pt>
                <c:pt idx="7">
                  <c:v>24</c:v>
                </c:pt>
                <c:pt idx="8">
                  <c:v>28</c:v>
                </c:pt>
              </c:numCache>
            </c:numRef>
          </c:xVal>
          <c:yVal>
            <c:numRef>
              <c:f>'[219 naive.xlsx]Sheet1'!$E$3:$E$11</c:f>
              <c:numCache>
                <c:formatCode>General</c:formatCode>
                <c:ptCount val="9"/>
                <c:pt idx="0">
                  <c:v>87.55</c:v>
                </c:pt>
                <c:pt idx="1">
                  <c:v>151.38</c:v>
                </c:pt>
                <c:pt idx="2">
                  <c:v>196.47</c:v>
                </c:pt>
                <c:pt idx="3">
                  <c:v>240.45</c:v>
                </c:pt>
                <c:pt idx="4">
                  <c:v>259.7</c:v>
                </c:pt>
                <c:pt idx="5">
                  <c:v>334.62</c:v>
                </c:pt>
                <c:pt idx="6">
                  <c:v>389.99</c:v>
                </c:pt>
                <c:pt idx="7">
                  <c:v>461.71</c:v>
                </c:pt>
                <c:pt idx="8">
                  <c:v>538.65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1-D5F9-4722-AB73-12F80F0BB3B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175081039"/>
        <c:axId val="1175090639"/>
        <c:extLst>
          <c:ext xmlns:c15="http://schemas.microsoft.com/office/drawing/2012/chart" uri="{02D57815-91ED-43cb-92C2-25804820EDAC}">
            <c15:filteredScatterSeries>
              <c15:ser>
                <c:idx val="0"/>
                <c:order val="0"/>
                <c:tx>
                  <c:strRef>
                    <c:extLst>
                      <c:ext uri="{02D57815-91ED-43cb-92C2-25804820EDAC}">
                        <c15:formulaRef>
                          <c15:sqref>'[219 naive.xlsx]Sheet1'!$B$2</c15:sqref>
                        </c15:formulaRef>
                      </c:ext>
                    </c:extLst>
                    <c:strCache>
                      <c:ptCount val="1"/>
                      <c:pt idx="0">
                        <c:v>14L</c:v>
                      </c:pt>
                    </c:strCache>
                  </c:strRef>
                </c:tx>
                <c:spPr>
                  <a:ln w="19050" cap="rnd">
                    <a:solidFill>
                      <a:schemeClr val="accent1"/>
                    </a:solidFill>
                    <a:round/>
                  </a:ln>
                  <a:effectLst/>
                </c:spPr>
                <c:marker>
                  <c:symbol val="circle"/>
                  <c:size val="5"/>
                  <c:spPr>
                    <a:solidFill>
                      <a:schemeClr val="accent1"/>
                    </a:solidFill>
                    <a:ln w="9525">
                      <a:solidFill>
                        <a:schemeClr val="accent1"/>
                      </a:solidFill>
                    </a:ln>
                    <a:effectLst/>
                  </c:spPr>
                </c:marker>
                <c:xVal>
                  <c:numRef>
                    <c:extLst>
                      <c:ext uri="{02D57815-91ED-43cb-92C2-25804820EDAC}">
                        <c15:formulaRef>
                          <c15:sqref>'[219 naive.xlsx]Sheet1'!$A$3:$A$11</c15:sqref>
                        </c15:formulaRef>
                      </c:ext>
                    </c:extLst>
                    <c:numCache>
                      <c:formatCode>General</c:formatCode>
                      <c:ptCount val="9"/>
                      <c:pt idx="0">
                        <c:v>0</c:v>
                      </c:pt>
                      <c:pt idx="1">
                        <c:v>3</c:v>
                      </c:pt>
                      <c:pt idx="2">
                        <c:v>7</c:v>
                      </c:pt>
                      <c:pt idx="3">
                        <c:v>10</c:v>
                      </c:pt>
                      <c:pt idx="4">
                        <c:v>14</c:v>
                      </c:pt>
                      <c:pt idx="5">
                        <c:v>17</c:v>
                      </c:pt>
                      <c:pt idx="6">
                        <c:v>21</c:v>
                      </c:pt>
                      <c:pt idx="7">
                        <c:v>24</c:v>
                      </c:pt>
                      <c:pt idx="8">
                        <c:v>28</c:v>
                      </c:pt>
                    </c:numCache>
                  </c:numRef>
                </c:xVal>
                <c:yVal>
                  <c:numRef>
                    <c:extLst>
                      <c:ext uri="{02D57815-91ED-43cb-92C2-25804820EDAC}">
                        <c15:formulaRef>
                          <c15:sqref>'[219 naive.xlsx]Sheet1'!$B$3:$B$11</c15:sqref>
                        </c15:formulaRef>
                      </c:ext>
                    </c:extLst>
                    <c:numCache>
                      <c:formatCode>General</c:formatCode>
                      <c:ptCount val="9"/>
                      <c:pt idx="0">
                        <c:v>49.39</c:v>
                      </c:pt>
                      <c:pt idx="1">
                        <c:v>116.03</c:v>
                      </c:pt>
                      <c:pt idx="2">
                        <c:v>172.65</c:v>
                      </c:pt>
                      <c:pt idx="3">
                        <c:v>202.55</c:v>
                      </c:pt>
                      <c:pt idx="4">
                        <c:v>285.91000000000003</c:v>
                      </c:pt>
                      <c:pt idx="5">
                        <c:v>334.61</c:v>
                      </c:pt>
                      <c:pt idx="6">
                        <c:v>487.35</c:v>
                      </c:pt>
                      <c:pt idx="7">
                        <c:v>550.38</c:v>
                      </c:pt>
                      <c:pt idx="8">
                        <c:v>639.27</c:v>
                      </c:pt>
                    </c:numCache>
                  </c:numRef>
                </c:yVal>
                <c:smooth val="1"/>
                <c:extLst>
                  <c:ext xmlns:c16="http://schemas.microsoft.com/office/drawing/2014/chart" uri="{C3380CC4-5D6E-409C-BE32-E72D297353CC}">
                    <c16:uniqueId val="{00000002-D5F9-4722-AB73-12F80F0BB3B3}"/>
                  </c:ext>
                </c:extLst>
              </c15:ser>
            </c15:filteredScatterSeries>
            <c15:filteredScatterSeries>
              <c15:ser>
                <c:idx val="1"/>
                <c:order val="1"/>
                <c:tx>
                  <c:str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[219 naive.xlsx]Sheet1'!$C$2</c15:sqref>
                        </c15:formulaRef>
                      </c:ext>
                    </c:extLst>
                    <c:strCache>
                      <c:ptCount val="1"/>
                      <c:pt idx="0">
                        <c:v>15L</c:v>
                      </c:pt>
                    </c:strCache>
                  </c:strRef>
                </c:tx>
                <c:spPr>
                  <a:ln w="19050" cap="rnd">
                    <a:solidFill>
                      <a:schemeClr val="accent2"/>
                    </a:solidFill>
                    <a:round/>
                  </a:ln>
                  <a:effectLst/>
                </c:spPr>
                <c:marker>
                  <c:symbol val="circle"/>
                  <c:size val="5"/>
                  <c:spPr>
                    <a:solidFill>
                      <a:schemeClr val="accent2"/>
                    </a:solidFill>
                    <a:ln w="9525">
                      <a:solidFill>
                        <a:schemeClr val="accent2"/>
                      </a:solidFill>
                    </a:ln>
                    <a:effectLst/>
                  </c:spPr>
                </c:marker>
                <c:xVal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[219 naive.xlsx]Sheet1'!$A$3:$A$11</c15:sqref>
                        </c15:formulaRef>
                      </c:ext>
                    </c:extLst>
                    <c:numCache>
                      <c:formatCode>General</c:formatCode>
                      <c:ptCount val="9"/>
                      <c:pt idx="0">
                        <c:v>0</c:v>
                      </c:pt>
                      <c:pt idx="1">
                        <c:v>3</c:v>
                      </c:pt>
                      <c:pt idx="2">
                        <c:v>7</c:v>
                      </c:pt>
                      <c:pt idx="3">
                        <c:v>10</c:v>
                      </c:pt>
                      <c:pt idx="4">
                        <c:v>14</c:v>
                      </c:pt>
                      <c:pt idx="5">
                        <c:v>17</c:v>
                      </c:pt>
                      <c:pt idx="6">
                        <c:v>21</c:v>
                      </c:pt>
                      <c:pt idx="7">
                        <c:v>24</c:v>
                      </c:pt>
                      <c:pt idx="8">
                        <c:v>28</c:v>
                      </c:pt>
                    </c:numCache>
                  </c:numRef>
                </c:xVal>
                <c:yVal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[219 naive.xlsx]Sheet1'!$C$3:$C$11</c15:sqref>
                        </c15:formulaRef>
                      </c:ext>
                    </c:extLst>
                    <c:numCache>
                      <c:formatCode>General</c:formatCode>
                      <c:ptCount val="9"/>
                      <c:pt idx="0">
                        <c:v>75.92</c:v>
                      </c:pt>
                      <c:pt idx="1">
                        <c:v>124.43</c:v>
                      </c:pt>
                      <c:pt idx="2">
                        <c:v>196.2</c:v>
                      </c:pt>
                      <c:pt idx="3">
                        <c:v>244.48</c:v>
                      </c:pt>
                      <c:pt idx="4">
                        <c:v>287.91999999999996</c:v>
                      </c:pt>
                      <c:pt idx="5">
                        <c:v>353.75</c:v>
                      </c:pt>
                      <c:pt idx="6">
                        <c:v>398.75</c:v>
                      </c:pt>
                      <c:pt idx="7">
                        <c:v>471.5</c:v>
                      </c:pt>
                      <c:pt idx="8">
                        <c:v>549.35</c:v>
                      </c:pt>
                    </c:numCache>
                  </c:numRef>
                </c:yVal>
                <c:smooth val="1"/>
                <c:extLst xmlns:c15="http://schemas.microsoft.com/office/drawing/2012/chart">
                  <c:ext xmlns:c16="http://schemas.microsoft.com/office/drawing/2014/chart" uri="{C3380CC4-5D6E-409C-BE32-E72D297353CC}">
                    <c16:uniqueId val="{00000003-D5F9-4722-AB73-12F80F0BB3B3}"/>
                  </c:ext>
                </c:extLst>
              </c15:ser>
            </c15:filteredScatterSeries>
          </c:ext>
        </c:extLst>
      </c:scatterChart>
      <c:valAx>
        <c:axId val="1175081039"/>
        <c:scaling>
          <c:orientation val="minMax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200" b="1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1200" b="1" dirty="0">
                    <a:solidFill>
                      <a:schemeClr val="tx1"/>
                    </a:solidFill>
                  </a:rPr>
                  <a:t>Days after first dosing</a:t>
                </a:r>
              </a:p>
            </c:rich>
          </c:tx>
          <c:layout>
            <c:manualLayout>
              <c:xMode val="edge"/>
              <c:yMode val="edge"/>
              <c:x val="0.31374195394949184"/>
              <c:y val="0.95307086614173231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200" b="1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rgbClr val="00206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175090639"/>
        <c:crosses val="autoZero"/>
        <c:crossBetween val="midCat"/>
      </c:valAx>
      <c:valAx>
        <c:axId val="1175090639"/>
        <c:scaling>
          <c:orientation val="minMax"/>
          <c:max val="70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200" b="1" i="0" u="none" strike="noStrike" kern="1200" baseline="0">
                    <a:solidFill>
                      <a:srgbClr val="002060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1200" b="1">
                    <a:solidFill>
                      <a:srgbClr val="002060"/>
                    </a:solidFill>
                  </a:rPr>
                  <a:t>Tumor Volume (mm3) </a:t>
                </a:r>
              </a:p>
            </c:rich>
          </c:tx>
          <c:layout>
            <c:manualLayout>
              <c:xMode val="edge"/>
              <c:yMode val="edge"/>
              <c:x val="3.0936497342056494E-3"/>
              <c:y val="0.22612811479490258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200" b="1" i="0" u="none" strike="noStrike" kern="1200" baseline="0">
                  <a:solidFill>
                    <a:srgbClr val="002060"/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rgbClr val="00206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175081039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solidFill>
        <a:srgbClr val="0070C0"/>
      </a:solidFill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37840" cy="466434"/>
          </a:xfrm>
          <a:prstGeom prst="rect">
            <a:avLst/>
          </a:prstGeom>
        </p:spPr>
        <p:txBody>
          <a:bodyPr vert="horz" lIns="93177" tIns="46589" rIns="93177" bIns="46589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970938" y="0"/>
            <a:ext cx="3037840" cy="466434"/>
          </a:xfrm>
          <a:prstGeom prst="rect">
            <a:avLst/>
          </a:prstGeom>
        </p:spPr>
        <p:txBody>
          <a:bodyPr vert="horz" lIns="93177" tIns="46589" rIns="93177" bIns="46589" rtlCol="0"/>
          <a:lstStyle>
            <a:lvl1pPr algn="r">
              <a:defRPr sz="1200"/>
            </a:lvl1pPr>
          </a:lstStyle>
          <a:p>
            <a:fld id="{45993433-F7F2-4C6C-8CEA-571C028B7E3B}" type="datetimeFigureOut">
              <a:rPr lang="en-US" smtClean="0"/>
              <a:t>7/10/2024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717550" y="1162050"/>
            <a:ext cx="5575300" cy="31369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3177" tIns="46589" rIns="93177" bIns="46589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01040" y="4473892"/>
            <a:ext cx="5608320" cy="3660458"/>
          </a:xfrm>
          <a:prstGeom prst="rect">
            <a:avLst/>
          </a:prstGeom>
        </p:spPr>
        <p:txBody>
          <a:bodyPr vert="horz" lIns="93177" tIns="46589" rIns="93177" bIns="46589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829967"/>
            <a:ext cx="3037840" cy="466433"/>
          </a:xfrm>
          <a:prstGeom prst="rect">
            <a:avLst/>
          </a:prstGeom>
        </p:spPr>
        <p:txBody>
          <a:bodyPr vert="horz" lIns="93177" tIns="46589" rIns="93177" bIns="46589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970938" y="8829967"/>
            <a:ext cx="3037840" cy="466433"/>
          </a:xfrm>
          <a:prstGeom prst="rect">
            <a:avLst/>
          </a:prstGeom>
        </p:spPr>
        <p:txBody>
          <a:bodyPr vert="horz" lIns="93177" tIns="46589" rIns="93177" bIns="46589" rtlCol="0" anchor="b"/>
          <a:lstStyle>
            <a:lvl1pPr algn="r">
              <a:defRPr sz="1200"/>
            </a:lvl1pPr>
          </a:lstStyle>
          <a:p>
            <a:fld id="{D60B8724-17CE-415A-8CAA-E4306F3CDB4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5640669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D60B8724-17CE-415A-8CAA-E4306F3CDB46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4808397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2B5F023-6B9D-4F6C-84DE-D209D78DC6E6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72BD839C-0DDB-41BF-856C-C3B39C102C19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DC0D240-2D15-407D-9E15-D21E4438BAE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B5986F-AD0D-48E4-A265-5F9327DC8D59}" type="datetimeFigureOut">
              <a:rPr lang="en-US" smtClean="0"/>
              <a:t>7/10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332F568-E783-4EAF-BF69-E8D77ADF44E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3AB7D21-2A4D-432A-A25C-7A822AA2CD8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E6CDB7-5727-4AF5-B558-0255E7A610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0229616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D10D481-E82C-4763-A46B-3CAC3AC1B51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EEFAF905-8D17-40EE-9F0F-031C8DCC5D2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F24E867-0298-40B3-8506-24DD95ACB76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B5986F-AD0D-48E4-A265-5F9327DC8D59}" type="datetimeFigureOut">
              <a:rPr lang="en-US" smtClean="0"/>
              <a:t>7/10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78460B8-2B95-408D-98B1-5B1AE6B1B30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7BDCA23-C798-481E-A10C-08733F1497F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E6CDB7-5727-4AF5-B558-0255E7A610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3574876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25EDEFD7-A864-4DBB-B0F4-45871EF21F43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9588068F-8E71-4C71-ABA1-4D44FD0E472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54F23A2-42B5-44F9-8475-5106DADBE58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B5986F-AD0D-48E4-A265-5F9327DC8D59}" type="datetimeFigureOut">
              <a:rPr lang="en-US" smtClean="0"/>
              <a:t>7/10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E600386-4D46-41B4-845D-ACDE5A0EA91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FC2386E-4D9E-4F33-8826-E419D59B109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E6CDB7-5727-4AF5-B558-0255E7A610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1752627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89AEE98-CF26-4465-850E-F1468D868D9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8BB96BD-E67F-48E4-BF7A-CD830E622A34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7F6D25E-A975-4654-9B05-7C635AA1BB8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B5986F-AD0D-48E4-A265-5F9327DC8D59}" type="datetimeFigureOut">
              <a:rPr lang="en-US" smtClean="0"/>
              <a:t>7/10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AACE4A7-40ED-4E19-AA8D-481AE0D8C4C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A839984-F76D-4FB2-AE5E-03B80A02901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E6CDB7-5727-4AF5-B558-0255E7A610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2753675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5C422F2-D875-4B0E-8FE9-2F3FFD08FDF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556EA26-C358-4F8B-9975-AC6AED2FF9F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A7D4841-4046-4643-9ACC-C54B17B051B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B5986F-AD0D-48E4-A265-5F9327DC8D59}" type="datetimeFigureOut">
              <a:rPr lang="en-US" smtClean="0"/>
              <a:t>7/10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BA98FF3-F7F1-4EC1-BC0A-41F74C7E7D7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CD808D9-BB84-4EA7-BDA2-864E35EB28D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E6CDB7-5727-4AF5-B558-0255E7A610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9689557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D0076C4-22E0-4326-A84F-D1D94E521BE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9630061-62B3-4285-A107-13BE6C67458D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43102929-66DC-4936-B62A-E0273285755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576273D-EB60-43B9-91D3-9F86025223B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B5986F-AD0D-48E4-A265-5F9327DC8D59}" type="datetimeFigureOut">
              <a:rPr lang="en-US" smtClean="0"/>
              <a:t>7/10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654C809-1DD0-4A7A-B024-55D0E508594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1F1B794-38F4-4A44-B657-411FC98B0F5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E6CDB7-5727-4AF5-B558-0255E7A610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9081186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BB37D37-0579-4906-8C69-D7F4A0D1372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6869939-8B7C-45FD-9101-3DF4E95B0EE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D8057093-4CF6-4645-B8E6-B0A742C1A01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F568530E-F8FA-40FD-B993-E47FC5BEE652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68F31B76-DB99-475F-8E0B-7CA688F3F1EA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93F7DC2F-BE93-4D60-9DDB-0A19F87B9E2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B5986F-AD0D-48E4-A265-5F9327DC8D59}" type="datetimeFigureOut">
              <a:rPr lang="en-US" smtClean="0"/>
              <a:t>7/10/2024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B31C0F25-7CF3-4DEC-B8BA-0C36CDCB47B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7D5915DC-B1EF-4AE7-A22F-3426E493A24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E6CDB7-5727-4AF5-B558-0255E7A610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5462478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D454793-0F06-4037-A3CA-352986DB34D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E947ED1E-806A-4EAF-A516-A855D82E04B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B5986F-AD0D-48E4-A265-5F9327DC8D59}" type="datetimeFigureOut">
              <a:rPr lang="en-US" smtClean="0"/>
              <a:t>7/10/2024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08FD2192-E901-42AB-B838-7AA63F9B895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7B9402FB-D8E6-4055-A522-7148BDE5937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E6CDB7-5727-4AF5-B558-0255E7A610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6060130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B62082F4-B039-4C82-A260-3BB96124CB3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B5986F-AD0D-48E4-A265-5F9327DC8D59}" type="datetimeFigureOut">
              <a:rPr lang="en-US" smtClean="0"/>
              <a:t>7/10/2024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831740F7-C780-47B4-9BAE-6238B09590F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B0B10FCD-0DC5-4700-A4DB-E0FD8D96A35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E6CDB7-5727-4AF5-B558-0255E7A610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9358319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BDF4661-E58C-47AE-8587-27776C730EC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E5D816B-9EFE-47D0-A3EE-4B78A3B4DD2C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8429021E-9C83-4590-9BE7-02E69DD0A20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C864328-7043-4B09-B23B-87CAD83157A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B5986F-AD0D-48E4-A265-5F9327DC8D59}" type="datetimeFigureOut">
              <a:rPr lang="en-US" smtClean="0"/>
              <a:t>7/10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33835B9-27B5-4CE7-BC6B-F68044392EC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0C0F6CE-1567-4130-9323-4FDE3684971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E6CDB7-5727-4AF5-B558-0255E7A610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3799110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6B9CF22-9B34-49BF-B2F2-FE5A6D2C67E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7F612AF4-E2A2-4384-B562-D16DAD9F14ED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12003EC2-7C65-4DDB-BB21-16E47ED4CF7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82C2E39-77CA-478E-AA71-EFB519CF7DE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B5986F-AD0D-48E4-A265-5F9327DC8D59}" type="datetimeFigureOut">
              <a:rPr lang="en-US" smtClean="0"/>
              <a:t>7/10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BD8EB90-5E72-4DC3-893A-11846CCCB65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AA50EAD-5388-4442-9400-90DC008E954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E6CDB7-5727-4AF5-B558-0255E7A610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8527109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5ACE4FFB-3949-4451-B74A-627781FF1C0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0D43352-3BF3-436B-B670-61850936F86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25287E0-7289-4F02-8FE8-3A03478BFB88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5B5986F-AD0D-48E4-A265-5F9327DC8D59}" type="datetimeFigureOut">
              <a:rPr lang="en-US" smtClean="0"/>
              <a:t>7/10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53035EB-C6F1-4E0D-83A4-D41B26357AE1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FD3A7A1-2762-4F2C-B324-AE6AAD2DBD52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4E6CDB7-5727-4AF5-B558-0255E7A610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1993030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.xml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4" Type="http://schemas.openxmlformats.org/officeDocument/2006/relationships/chart" Target="../charts/char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Chart 2">
            <a:extLst>
              <a:ext uri="{FF2B5EF4-FFF2-40B4-BE49-F238E27FC236}">
                <a16:creationId xmlns:a16="http://schemas.microsoft.com/office/drawing/2014/main" id="{72ADC21E-4590-F05C-187E-16F31C462A8D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641290876"/>
              </p:ext>
            </p:extLst>
          </p:nvPr>
        </p:nvGraphicFramePr>
        <p:xfrm>
          <a:off x="3049056" y="1297632"/>
          <a:ext cx="2951530" cy="313170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4" name="Chart 3">
            <a:extLst>
              <a:ext uri="{FF2B5EF4-FFF2-40B4-BE49-F238E27FC236}">
                <a16:creationId xmlns:a16="http://schemas.microsoft.com/office/drawing/2014/main" id="{72ADC21E-4590-F05C-187E-16F31C462A8D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827210646"/>
              </p:ext>
            </p:extLst>
          </p:nvPr>
        </p:nvGraphicFramePr>
        <p:xfrm>
          <a:off x="6264568" y="1297632"/>
          <a:ext cx="2951530" cy="313170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6" name="TextBox 5">
            <a:extLst>
              <a:ext uri="{FF2B5EF4-FFF2-40B4-BE49-F238E27FC236}">
                <a16:creationId xmlns:a16="http://schemas.microsoft.com/office/drawing/2014/main" id="{3FCD1E82-9A4F-CC35-F85D-122F5B0EFA63}"/>
              </a:ext>
            </a:extLst>
          </p:cNvPr>
          <p:cNvSpPr txBox="1"/>
          <p:nvPr/>
        </p:nvSpPr>
        <p:spPr>
          <a:xfrm>
            <a:off x="3049054" y="1297632"/>
            <a:ext cx="169207" cy="217036"/>
          </a:xfrm>
          <a:prstGeom prst="rect">
            <a:avLst/>
          </a:prstGeom>
        </p:spPr>
        <p:style>
          <a:lnRef idx="2">
            <a:schemeClr val="dk1">
              <a:shade val="15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wrap="none" lIns="0" tIns="0" rIns="0" bIns="0" rtlCol="0">
            <a:spAutoFit/>
          </a:bodyPr>
          <a:lstStyle/>
          <a:p>
            <a:r>
              <a:rPr lang="en-US" sz="1400" b="1" dirty="0"/>
              <a:t> A 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0E621AD0-6DE7-EA2F-2D89-87C35C3838F3}"/>
              </a:ext>
            </a:extLst>
          </p:cNvPr>
          <p:cNvSpPr txBox="1"/>
          <p:nvPr/>
        </p:nvSpPr>
        <p:spPr>
          <a:xfrm>
            <a:off x="6264568" y="1299224"/>
            <a:ext cx="181140" cy="215444"/>
          </a:xfrm>
          <a:prstGeom prst="rect">
            <a:avLst/>
          </a:prstGeom>
        </p:spPr>
        <p:style>
          <a:lnRef idx="2">
            <a:schemeClr val="dk1">
              <a:shade val="15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wrap="none" lIns="0" tIns="0" rIns="0" bIns="0" rtlCol="0">
            <a:spAutoFit/>
          </a:bodyPr>
          <a:lstStyle/>
          <a:p>
            <a:r>
              <a:rPr lang="en-US" sz="1400" b="1" dirty="0"/>
              <a:t> B 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A763E5BA-3F8C-190F-8902-D2F5F02918FC}"/>
              </a:ext>
            </a:extLst>
          </p:cNvPr>
          <p:cNvSpPr txBox="1"/>
          <p:nvPr/>
        </p:nvSpPr>
        <p:spPr>
          <a:xfrm>
            <a:off x="4339691" y="1514668"/>
            <a:ext cx="527530" cy="203133"/>
          </a:xfrm>
          <a:prstGeom prst="rect">
            <a:avLst/>
          </a:prstGeom>
        </p:spPr>
        <p:style>
          <a:lnRef idx="1">
            <a:schemeClr val="accent5"/>
          </a:lnRef>
          <a:fillRef idx="2">
            <a:schemeClr val="accent5"/>
          </a:fillRef>
          <a:effectRef idx="1">
            <a:schemeClr val="accent5"/>
          </a:effectRef>
          <a:fontRef idx="minor">
            <a:schemeClr val="dk1"/>
          </a:fontRef>
        </p:style>
        <p:txBody>
          <a:bodyPr wrap="square" lIns="91440" tIns="9144" bIns="9144" rtlCol="0" anchor="ctr">
            <a:spAutoFit/>
          </a:bodyPr>
          <a:lstStyle/>
          <a:p>
            <a:pPr algn="ctr"/>
            <a:r>
              <a:rPr lang="en-US" sz="1200" b="1" dirty="0"/>
              <a:t>PBS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59F21F46-71A2-F14E-A111-DC30B1886E58}"/>
              </a:ext>
            </a:extLst>
          </p:cNvPr>
          <p:cNvSpPr txBox="1"/>
          <p:nvPr/>
        </p:nvSpPr>
        <p:spPr>
          <a:xfrm>
            <a:off x="7541500" y="1514668"/>
            <a:ext cx="1032324" cy="387798"/>
          </a:xfrm>
          <a:prstGeom prst="rect">
            <a:avLst/>
          </a:prstGeom>
        </p:spPr>
        <p:style>
          <a:lnRef idx="1">
            <a:schemeClr val="accent6"/>
          </a:lnRef>
          <a:fillRef idx="2">
            <a:schemeClr val="accent6"/>
          </a:fillRef>
          <a:effectRef idx="1">
            <a:schemeClr val="accent6"/>
          </a:effectRef>
          <a:fontRef idx="minor">
            <a:schemeClr val="dk1"/>
          </a:fontRef>
        </p:style>
        <p:txBody>
          <a:bodyPr wrap="square" lIns="91440" tIns="9144" bIns="9144" rtlCol="0" anchor="ctr">
            <a:spAutoFit/>
          </a:bodyPr>
          <a:lstStyle/>
          <a:p>
            <a:pPr algn="ctr"/>
            <a:r>
              <a:rPr lang="en-US" sz="1200" b="1" dirty="0"/>
              <a:t>Anti-HDGF antibody  H3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F1EE9AC3-EDFC-D2A3-2E47-577AFA2EA41B}"/>
              </a:ext>
            </a:extLst>
          </p:cNvPr>
          <p:cNvSpPr txBox="1"/>
          <p:nvPr/>
        </p:nvSpPr>
        <p:spPr>
          <a:xfrm>
            <a:off x="1656182" y="4778017"/>
            <a:ext cx="8952788" cy="156151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>
              <a:lnSpc>
                <a:spcPct val="107000"/>
              </a:lnSpc>
              <a:spcBef>
                <a:spcPts val="0"/>
              </a:spcBef>
              <a:spcAft>
                <a:spcPts val="0"/>
              </a:spcAft>
            </a:pPr>
            <a:r>
              <a:rPr lang="en-US" sz="1800" b="1" kern="1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Supplement Figure 2. Effect of anti-HDGF antibody </a:t>
            </a:r>
            <a:r>
              <a:rPr lang="en-US" sz="1800" b="1" kern="100" dirty="0" err="1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H3</a:t>
            </a:r>
            <a:r>
              <a:rPr lang="en-US" sz="1800" b="1" kern="1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 on treatment naive tumor</a:t>
            </a:r>
            <a:endParaRPr lang="en-US" sz="1800" kern="100" dirty="0">
              <a:effectLst/>
              <a:latin typeface="Aptos" panose="020B0004020202020204" pitchFamily="34" charset="0"/>
              <a:ea typeface="Aptos" panose="020B0004020202020204" pitchFamily="34" charset="0"/>
              <a:cs typeface="Times New Roman" panose="02020603050405020304" pitchFamily="18" charset="0"/>
            </a:endParaRPr>
          </a:p>
          <a:p>
            <a:pPr marL="0" marR="0">
              <a:lnSpc>
                <a:spcPct val="107000"/>
              </a:lnSpc>
              <a:spcBef>
                <a:spcPts val="0"/>
              </a:spcBef>
              <a:spcAft>
                <a:spcPts val="0"/>
              </a:spcAft>
            </a:pPr>
            <a:r>
              <a:rPr lang="en-US" sz="1800" kern="1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Mice bearing established </a:t>
            </a:r>
            <a:r>
              <a:rPr lang="en-US" sz="1800" kern="100" dirty="0" err="1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TM00219</a:t>
            </a:r>
            <a:r>
              <a:rPr lang="en-US" sz="1800" kern="1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 PDX tumor (49 to 106 </a:t>
            </a:r>
            <a:r>
              <a:rPr lang="en-US" sz="1800" kern="100" dirty="0" err="1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mm</a:t>
            </a:r>
            <a:r>
              <a:rPr lang="en-US" sz="1800" kern="100" baseline="30000" dirty="0" err="1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3</a:t>
            </a:r>
            <a:r>
              <a:rPr lang="en-US" sz="1800" kern="1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) were randomized to receive PBS or anti-HDGF antibody </a:t>
            </a:r>
            <a:r>
              <a:rPr lang="en-US" sz="1800" kern="100" dirty="0" err="1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H3</a:t>
            </a:r>
            <a:r>
              <a:rPr lang="en-US" sz="1800" kern="1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 (13 mg/kg, </a:t>
            </a:r>
            <a:r>
              <a:rPr lang="en-US" sz="1800" kern="100" dirty="0" err="1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i.p.</a:t>
            </a:r>
            <a:r>
              <a:rPr lang="en-US" sz="1800" kern="1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, </a:t>
            </a:r>
            <a:r>
              <a:rPr lang="en-US" sz="1800" kern="100" dirty="0" err="1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b.i.w</a:t>
            </a:r>
            <a:r>
              <a:rPr lang="en-US" sz="1800" kern="1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.). Tumor volumes were measured twice a week and plotted as a spider plot of tumor volume changes over the treatment course. </a:t>
            </a:r>
            <a:r>
              <a:rPr lang="en-US" sz="1800" b="1" kern="1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A</a:t>
            </a:r>
            <a:r>
              <a:rPr lang="en-US" sz="1800" kern="1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, PBS arm. </a:t>
            </a:r>
            <a:r>
              <a:rPr lang="en-US" sz="1800" b="1" kern="1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B</a:t>
            </a:r>
            <a:r>
              <a:rPr lang="en-US" sz="1800" kern="1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, </a:t>
            </a:r>
            <a:r>
              <a:rPr lang="en-US" sz="1800" kern="100" dirty="0" err="1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H3</a:t>
            </a:r>
            <a:r>
              <a:rPr lang="en-US" sz="1800" kern="1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 arm.  </a:t>
            </a:r>
            <a:endParaRPr lang="en-US" sz="1800" kern="100" dirty="0">
              <a:effectLst/>
              <a:latin typeface="Aptos" panose="020B0004020202020204" pitchFamily="34" charset="0"/>
              <a:ea typeface="Aptos" panose="020B000402020202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26049392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9937</TotalTime>
  <Words>109</Words>
  <Application>Microsoft Office PowerPoint</Application>
  <PresentationFormat>Widescreen</PresentationFormat>
  <Paragraphs>11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ptos</vt:lpstr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Ren, Hening</dc:creator>
  <cp:lastModifiedBy>Ren, Hening</cp:lastModifiedBy>
  <cp:revision>30</cp:revision>
  <cp:lastPrinted>2024-01-09T16:49:54Z</cp:lastPrinted>
  <dcterms:created xsi:type="dcterms:W3CDTF">2022-08-03T20:55:56Z</dcterms:created>
  <dcterms:modified xsi:type="dcterms:W3CDTF">2024-07-10T16:41:32Z</dcterms:modified>
</cp:coreProperties>
</file>